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6FE94-2F2A-4046-9860-E2A7ED4347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9542E-E00B-41F1-B0C1-ABF8784F9F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F24EA-175C-44DF-B90B-0B388717C7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A1E84-6B46-4335-8683-8C6F7C6CC2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31F9D-466F-41E3-A90B-DB1DB1EE79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AD202-679E-42D3-A0C8-FF1E561482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429D4-B864-476D-99CB-8C06FA0612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C75FC-92E5-4175-8FD0-59F103AB74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7E455-A3DE-49BB-AD9F-1139C16AC4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2E44B-90B3-4C34-80F5-46D121FDD1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34FC1-527A-4D29-A4D7-EB73E8E091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A636C-D568-4935-BD56-04AB724BB3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C277E0-EB63-4E70-BF1F-2D6FB770E15D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1"/>
          <p:cNvSpPr/>
          <p:nvPr/>
        </p:nvSpPr>
        <p:spPr>
          <a:xfrm>
            <a:off x="549360" y="333360"/>
            <a:ext cx="2604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Box 11"/>
          <p:cNvSpPr/>
          <p:nvPr/>
        </p:nvSpPr>
        <p:spPr>
          <a:xfrm>
            <a:off x="549360" y="4951440"/>
            <a:ext cx="489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3" name="그림 3" descr=""/>
          <p:cNvPicPr/>
          <p:nvPr/>
        </p:nvPicPr>
        <p:blipFill>
          <a:blip r:embed="rId1"/>
          <a:srcRect l="1701" t="8501" r="1701" b="2894"/>
          <a:stretch/>
        </p:blipFill>
        <p:spPr>
          <a:xfrm>
            <a:off x="1500120" y="5010120"/>
            <a:ext cx="3745080" cy="3214800"/>
          </a:xfrm>
          <a:prstGeom prst="rect">
            <a:avLst/>
          </a:prstGeom>
          <a:ln w="0">
            <a:noFill/>
          </a:ln>
        </p:spPr>
      </p:pic>
      <p:pic>
        <p:nvPicPr>
          <p:cNvPr id="44" name="그림 1" descr=""/>
          <p:cNvPicPr/>
          <p:nvPr/>
        </p:nvPicPr>
        <p:blipFill>
          <a:blip r:embed="rId2"/>
          <a:srcRect l="926" t="9024" r="2731" b="3790"/>
          <a:stretch/>
        </p:blipFill>
        <p:spPr>
          <a:xfrm>
            <a:off x="1009800" y="399960"/>
            <a:ext cx="4871880" cy="2724120"/>
          </a:xfrm>
          <a:prstGeom prst="rect">
            <a:avLst/>
          </a:prstGeom>
          <a:ln w="0">
            <a:noFill/>
          </a:ln>
        </p:spPr>
      </p:pic>
      <p:grpSp>
        <p:nvGrpSpPr>
          <p:cNvPr id="45" name="그룹 2"/>
          <p:cNvGrpSpPr/>
          <p:nvPr/>
        </p:nvGrpSpPr>
        <p:grpSpPr>
          <a:xfrm>
            <a:off x="1069920" y="3146400"/>
            <a:ext cx="4751280" cy="1944720"/>
            <a:chOff x="1069920" y="3146400"/>
            <a:chExt cx="4751280" cy="1944720"/>
          </a:xfrm>
        </p:grpSpPr>
        <p:pic>
          <p:nvPicPr>
            <p:cNvPr id="46" name="그림 2" descr=""/>
            <p:cNvPicPr/>
            <p:nvPr/>
          </p:nvPicPr>
          <p:blipFill>
            <a:blip r:embed="rId3"/>
            <a:srcRect l="1701" t="10098" r="1701" b="7882"/>
            <a:stretch/>
          </p:blipFill>
          <p:spPr>
            <a:xfrm>
              <a:off x="1069920" y="3179520"/>
              <a:ext cx="4751280" cy="1911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직사각형 1"/>
            <p:cNvSpPr/>
            <p:nvPr/>
          </p:nvSpPr>
          <p:spPr>
            <a:xfrm>
              <a:off x="1077840" y="3146400"/>
              <a:ext cx="10792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48" name="TextBox 11"/>
          <p:cNvSpPr/>
          <p:nvPr/>
        </p:nvSpPr>
        <p:spPr>
          <a:xfrm>
            <a:off x="549360" y="3008160"/>
            <a:ext cx="489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138240" y="8164440"/>
            <a:ext cx="67197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 |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etabolic pathways differentially expressed in MRSA treated with NaP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mong the eight significantly enriched KEGG pathways, a subset of metabolic pathways showing differential expression by NaP treatment include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purine metabolism;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riboflavin metabolism;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glycine, serine, and threonine metabolism. Green and red highlights indicate up- and down-regulated DEGs in the assigned pathway, respectively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TextBox 8"/>
          <p:cNvSpPr/>
          <p:nvPr/>
        </p:nvSpPr>
        <p:spPr>
          <a:xfrm>
            <a:off x="1528920" y="-36360"/>
            <a:ext cx="381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2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07:45:37Z</dcterms:created>
  <dc:creator>조민경</dc:creator>
  <dc:description/>
  <dc:language>en-US</dc:language>
  <cp:lastModifiedBy>임진택</cp:lastModifiedBy>
  <cp:lastPrinted>2022-01-06T07:05:04Z</cp:lastPrinted>
  <dcterms:modified xsi:type="dcterms:W3CDTF">2022-10-04T08:53:45Z</dcterms:modified>
  <cp:revision>512</cp:revision>
  <dc:subject/>
  <dc:title>슬라이드 1</dc:title>
</cp:coreProperties>
</file>